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59" r:id="rId4"/>
    <p:sldId id="265" r:id="rId5"/>
    <p:sldId id="266" r:id="rId6"/>
  </p:sldIdLst>
  <p:sldSz cx="43205400" cy="34204275"/>
  <p:notesSz cx="6784975" cy="9906000"/>
  <p:defaultTextStyle>
    <a:defPPr>
      <a:defRPr lang="it-IT"/>
    </a:defPPr>
    <a:lvl1pPr algn="l" defTabSz="3908425" rtl="0" fontAlgn="base">
      <a:spcBef>
        <a:spcPct val="0"/>
      </a:spcBef>
      <a:spcAft>
        <a:spcPct val="0"/>
      </a:spcAft>
      <a:defRPr sz="77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1954213" indent="-1497013" algn="l" defTabSz="3908425" rtl="0" fontAlgn="base">
      <a:spcBef>
        <a:spcPct val="0"/>
      </a:spcBef>
      <a:spcAft>
        <a:spcPct val="0"/>
      </a:spcAft>
      <a:defRPr sz="77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3908425" indent="-2994025" algn="l" defTabSz="3908425" rtl="0" fontAlgn="base">
      <a:spcBef>
        <a:spcPct val="0"/>
      </a:spcBef>
      <a:spcAft>
        <a:spcPct val="0"/>
      </a:spcAft>
      <a:defRPr sz="77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5862638" indent="-4491038" algn="l" defTabSz="3908425" rtl="0" fontAlgn="base">
      <a:spcBef>
        <a:spcPct val="0"/>
      </a:spcBef>
      <a:spcAft>
        <a:spcPct val="0"/>
      </a:spcAft>
      <a:defRPr sz="77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7816850" indent="-5988050" algn="l" defTabSz="3908425" rtl="0" fontAlgn="base">
      <a:spcBef>
        <a:spcPct val="0"/>
      </a:spcBef>
      <a:spcAft>
        <a:spcPct val="0"/>
      </a:spcAft>
      <a:defRPr sz="77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7700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7700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7700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7700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10773">
          <p15:clr>
            <a:srgbClr val="A4A3A4"/>
          </p15:clr>
        </p15:guide>
        <p15:guide id="2" pos="136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41" autoAdjust="0"/>
    <p:restoredTop sz="94660"/>
  </p:normalViewPr>
  <p:slideViewPr>
    <p:cSldViewPr>
      <p:cViewPr varScale="1">
        <p:scale>
          <a:sx n="22" d="100"/>
          <a:sy n="22" d="100"/>
        </p:scale>
        <p:origin x="1746" y="114"/>
      </p:cViewPr>
      <p:guideLst>
        <p:guide orient="horz" pos="10773"/>
        <p:guide pos="1360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3240406" y="10625499"/>
            <a:ext cx="36724590" cy="7331750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6480810" y="19382425"/>
            <a:ext cx="30243780" cy="874109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954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909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8635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818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7726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1727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36817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5636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D323C-CA12-4992-8DA4-C939ED6DFD19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550030-1A3A-4DAB-8829-83A45283036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660914-50E4-4421-AB6A-BA29BD2ED8FD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EFB1A7-F51D-4850-9187-5D445BAB8D2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1323915" y="1369762"/>
            <a:ext cx="9721216" cy="29184481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160270" y="1369762"/>
            <a:ext cx="28443556" cy="29184481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202B2D-6F9B-45A5-8840-82C09E81B730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598322-AFF9-41D9-98B5-6F3511FAAAC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B9EC06-101B-4B6F-8726-CB5BE18B029E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5FB4F1-E133-4779-BB96-1170A8E1FB9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12929" y="21979417"/>
            <a:ext cx="36724590" cy="6793349"/>
          </a:xfrm>
        </p:spPr>
        <p:txBody>
          <a:bodyPr anchor="t"/>
          <a:lstStyle>
            <a:lvl1pPr algn="l">
              <a:defRPr sz="171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12929" y="14497233"/>
            <a:ext cx="36724590" cy="7482183"/>
          </a:xfrm>
        </p:spPr>
        <p:txBody>
          <a:bodyPr anchor="b"/>
          <a:lstStyle>
            <a:lvl1pPr marL="0" indent="0">
              <a:buNone/>
              <a:defRPr sz="8600">
                <a:solidFill>
                  <a:schemeClr val="tx1">
                    <a:tint val="75000"/>
                  </a:schemeClr>
                </a:solidFill>
              </a:defRPr>
            </a:lvl1pPr>
            <a:lvl2pPr marL="1954530" indent="0">
              <a:buNone/>
              <a:defRPr sz="7700">
                <a:solidFill>
                  <a:schemeClr val="tx1">
                    <a:tint val="75000"/>
                  </a:schemeClr>
                </a:solidFill>
              </a:defRPr>
            </a:lvl2pPr>
            <a:lvl3pPr marL="3909060" indent="0">
              <a:buNone/>
              <a:defRPr sz="6800">
                <a:solidFill>
                  <a:schemeClr val="tx1">
                    <a:tint val="75000"/>
                  </a:schemeClr>
                </a:solidFill>
              </a:defRPr>
            </a:lvl3pPr>
            <a:lvl4pPr marL="586359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4pPr>
            <a:lvl5pPr marL="781812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5pPr>
            <a:lvl6pPr marL="977265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6pPr>
            <a:lvl7pPr marL="1172718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7pPr>
            <a:lvl8pPr marL="1368171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8pPr>
            <a:lvl9pPr marL="1563624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2807FF-FF59-4FA9-9B2C-0D715E23B9D2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216277-4795-4F9D-9F92-2F2F76BCA2B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160270" y="7981001"/>
            <a:ext cx="19082386" cy="22573240"/>
          </a:xfrm>
        </p:spPr>
        <p:txBody>
          <a:bodyPr/>
          <a:lstStyle>
            <a:lvl1pPr>
              <a:defRPr sz="12000"/>
            </a:lvl1pPr>
            <a:lvl2pPr>
              <a:defRPr sz="10300"/>
            </a:lvl2pPr>
            <a:lvl3pPr>
              <a:defRPr sz="8600"/>
            </a:lvl3pPr>
            <a:lvl4pPr>
              <a:defRPr sz="7700"/>
            </a:lvl4pPr>
            <a:lvl5pPr>
              <a:defRPr sz="7700"/>
            </a:lvl5pPr>
            <a:lvl6pPr>
              <a:defRPr sz="7700"/>
            </a:lvl6pPr>
            <a:lvl7pPr>
              <a:defRPr sz="7700"/>
            </a:lvl7pPr>
            <a:lvl8pPr>
              <a:defRPr sz="7700"/>
            </a:lvl8pPr>
            <a:lvl9pPr>
              <a:defRPr sz="77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1962744" y="7981001"/>
            <a:ext cx="19082386" cy="22573240"/>
          </a:xfrm>
        </p:spPr>
        <p:txBody>
          <a:bodyPr/>
          <a:lstStyle>
            <a:lvl1pPr>
              <a:defRPr sz="12000"/>
            </a:lvl1pPr>
            <a:lvl2pPr>
              <a:defRPr sz="10300"/>
            </a:lvl2pPr>
            <a:lvl3pPr>
              <a:defRPr sz="8600"/>
            </a:lvl3pPr>
            <a:lvl4pPr>
              <a:defRPr sz="7700"/>
            </a:lvl4pPr>
            <a:lvl5pPr>
              <a:defRPr sz="7700"/>
            </a:lvl5pPr>
            <a:lvl6pPr>
              <a:defRPr sz="7700"/>
            </a:lvl6pPr>
            <a:lvl7pPr>
              <a:defRPr sz="7700"/>
            </a:lvl7pPr>
            <a:lvl8pPr>
              <a:defRPr sz="7700"/>
            </a:lvl8pPr>
            <a:lvl9pPr>
              <a:defRPr sz="77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FB8C64-58D1-435B-8F44-CEA3CE8AF7F0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EE416-F9C4-4F25-B991-2DD10569AFC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160270" y="7656379"/>
            <a:ext cx="19089888" cy="3190813"/>
          </a:xfrm>
        </p:spPr>
        <p:txBody>
          <a:bodyPr anchor="b"/>
          <a:lstStyle>
            <a:lvl1pPr marL="0" indent="0">
              <a:buNone/>
              <a:defRPr sz="10300" b="1"/>
            </a:lvl1pPr>
            <a:lvl2pPr marL="1954530" indent="0">
              <a:buNone/>
              <a:defRPr sz="8600" b="1"/>
            </a:lvl2pPr>
            <a:lvl3pPr marL="3909060" indent="0">
              <a:buNone/>
              <a:defRPr sz="7700" b="1"/>
            </a:lvl3pPr>
            <a:lvl4pPr marL="5863590" indent="0">
              <a:buNone/>
              <a:defRPr sz="6800" b="1"/>
            </a:lvl4pPr>
            <a:lvl5pPr marL="7818120" indent="0">
              <a:buNone/>
              <a:defRPr sz="6800" b="1"/>
            </a:lvl5pPr>
            <a:lvl6pPr marL="9772650" indent="0">
              <a:buNone/>
              <a:defRPr sz="6800" b="1"/>
            </a:lvl6pPr>
            <a:lvl7pPr marL="11727180" indent="0">
              <a:buNone/>
              <a:defRPr sz="6800" b="1"/>
            </a:lvl7pPr>
            <a:lvl8pPr marL="13681710" indent="0">
              <a:buNone/>
              <a:defRPr sz="6800" b="1"/>
            </a:lvl8pPr>
            <a:lvl9pPr marL="15636240" indent="0">
              <a:buNone/>
              <a:defRPr sz="68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160270" y="10847189"/>
            <a:ext cx="19089888" cy="19707049"/>
          </a:xfrm>
        </p:spPr>
        <p:txBody>
          <a:bodyPr/>
          <a:lstStyle>
            <a:lvl1pPr>
              <a:defRPr sz="10300"/>
            </a:lvl1pPr>
            <a:lvl2pPr>
              <a:defRPr sz="8600"/>
            </a:lvl2pPr>
            <a:lvl3pPr>
              <a:defRPr sz="7700"/>
            </a:lvl3pPr>
            <a:lvl4pPr>
              <a:defRPr sz="6800"/>
            </a:lvl4pPr>
            <a:lvl5pPr>
              <a:defRPr sz="6800"/>
            </a:lvl5pPr>
            <a:lvl6pPr>
              <a:defRPr sz="6800"/>
            </a:lvl6pPr>
            <a:lvl7pPr>
              <a:defRPr sz="6800"/>
            </a:lvl7pPr>
            <a:lvl8pPr>
              <a:defRPr sz="6800"/>
            </a:lvl8pPr>
            <a:lvl9pPr>
              <a:defRPr sz="6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21947749" y="7656379"/>
            <a:ext cx="19097387" cy="3190813"/>
          </a:xfrm>
        </p:spPr>
        <p:txBody>
          <a:bodyPr anchor="b"/>
          <a:lstStyle>
            <a:lvl1pPr marL="0" indent="0">
              <a:buNone/>
              <a:defRPr sz="10300" b="1"/>
            </a:lvl1pPr>
            <a:lvl2pPr marL="1954530" indent="0">
              <a:buNone/>
              <a:defRPr sz="8600" b="1"/>
            </a:lvl2pPr>
            <a:lvl3pPr marL="3909060" indent="0">
              <a:buNone/>
              <a:defRPr sz="7700" b="1"/>
            </a:lvl3pPr>
            <a:lvl4pPr marL="5863590" indent="0">
              <a:buNone/>
              <a:defRPr sz="6800" b="1"/>
            </a:lvl4pPr>
            <a:lvl5pPr marL="7818120" indent="0">
              <a:buNone/>
              <a:defRPr sz="6800" b="1"/>
            </a:lvl5pPr>
            <a:lvl6pPr marL="9772650" indent="0">
              <a:buNone/>
              <a:defRPr sz="6800" b="1"/>
            </a:lvl6pPr>
            <a:lvl7pPr marL="11727180" indent="0">
              <a:buNone/>
              <a:defRPr sz="6800" b="1"/>
            </a:lvl7pPr>
            <a:lvl8pPr marL="13681710" indent="0">
              <a:buNone/>
              <a:defRPr sz="6800" b="1"/>
            </a:lvl8pPr>
            <a:lvl9pPr marL="15636240" indent="0">
              <a:buNone/>
              <a:defRPr sz="68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21947749" y="10847189"/>
            <a:ext cx="19097387" cy="19707049"/>
          </a:xfrm>
        </p:spPr>
        <p:txBody>
          <a:bodyPr/>
          <a:lstStyle>
            <a:lvl1pPr>
              <a:defRPr sz="10300"/>
            </a:lvl1pPr>
            <a:lvl2pPr>
              <a:defRPr sz="8600"/>
            </a:lvl2pPr>
            <a:lvl3pPr>
              <a:defRPr sz="7700"/>
            </a:lvl3pPr>
            <a:lvl4pPr>
              <a:defRPr sz="6800"/>
            </a:lvl4pPr>
            <a:lvl5pPr>
              <a:defRPr sz="6800"/>
            </a:lvl5pPr>
            <a:lvl6pPr>
              <a:defRPr sz="6800"/>
            </a:lvl6pPr>
            <a:lvl7pPr>
              <a:defRPr sz="6800"/>
            </a:lvl7pPr>
            <a:lvl8pPr>
              <a:defRPr sz="6800"/>
            </a:lvl8pPr>
            <a:lvl9pPr>
              <a:defRPr sz="6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017D8D-81AF-4026-97CE-6555D276D706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02FC3D-1C73-4E8A-8F0C-6F6CFA6BB30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ABF477-B445-4DC8-B8AC-B86B98AA2E9E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D6D518-9C3E-42B9-A9B4-301D1A373D7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677DFB-AE25-4707-BD1C-B2680A8CC46A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3B6A56-D474-4EE4-9F05-F2091E6C149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160273" y="1361837"/>
            <a:ext cx="14214278" cy="5795724"/>
          </a:xfrm>
        </p:spPr>
        <p:txBody>
          <a:bodyPr anchor="b"/>
          <a:lstStyle>
            <a:lvl1pPr algn="l">
              <a:defRPr sz="86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6892114" y="1361842"/>
            <a:ext cx="24153019" cy="29192402"/>
          </a:xfrm>
        </p:spPr>
        <p:txBody>
          <a:bodyPr/>
          <a:lstStyle>
            <a:lvl1pPr>
              <a:defRPr sz="13700"/>
            </a:lvl1pPr>
            <a:lvl2pPr>
              <a:defRPr sz="12000"/>
            </a:lvl2pPr>
            <a:lvl3pPr>
              <a:defRPr sz="10300"/>
            </a:lvl3pPr>
            <a:lvl4pPr>
              <a:defRPr sz="8600"/>
            </a:lvl4pPr>
            <a:lvl5pPr>
              <a:defRPr sz="8600"/>
            </a:lvl5pPr>
            <a:lvl6pPr>
              <a:defRPr sz="8600"/>
            </a:lvl6pPr>
            <a:lvl7pPr>
              <a:defRPr sz="8600"/>
            </a:lvl7pPr>
            <a:lvl8pPr>
              <a:defRPr sz="8600"/>
            </a:lvl8pPr>
            <a:lvl9pPr>
              <a:defRPr sz="8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160273" y="7157567"/>
            <a:ext cx="14214278" cy="23396677"/>
          </a:xfrm>
        </p:spPr>
        <p:txBody>
          <a:bodyPr/>
          <a:lstStyle>
            <a:lvl1pPr marL="0" indent="0">
              <a:buNone/>
              <a:defRPr sz="6000"/>
            </a:lvl1pPr>
            <a:lvl2pPr marL="1954530" indent="0">
              <a:buNone/>
              <a:defRPr sz="5100"/>
            </a:lvl2pPr>
            <a:lvl3pPr marL="3909060" indent="0">
              <a:buNone/>
              <a:defRPr sz="4300"/>
            </a:lvl3pPr>
            <a:lvl4pPr marL="5863590" indent="0">
              <a:buNone/>
              <a:defRPr sz="3800"/>
            </a:lvl4pPr>
            <a:lvl5pPr marL="7818120" indent="0">
              <a:buNone/>
              <a:defRPr sz="3800"/>
            </a:lvl5pPr>
            <a:lvl6pPr marL="9772650" indent="0">
              <a:buNone/>
              <a:defRPr sz="3800"/>
            </a:lvl6pPr>
            <a:lvl7pPr marL="11727180" indent="0">
              <a:buNone/>
              <a:defRPr sz="3800"/>
            </a:lvl7pPr>
            <a:lvl8pPr marL="13681710" indent="0">
              <a:buNone/>
              <a:defRPr sz="3800"/>
            </a:lvl8pPr>
            <a:lvl9pPr marL="15636240" indent="0">
              <a:buNone/>
              <a:defRPr sz="38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E0386D-F12C-4637-9A8B-3119C695C1AE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E7F33B-3715-4A00-8668-18F91679DBE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468561" y="23942994"/>
            <a:ext cx="25923240" cy="2826606"/>
          </a:xfrm>
        </p:spPr>
        <p:txBody>
          <a:bodyPr anchor="b"/>
          <a:lstStyle>
            <a:lvl1pPr algn="l">
              <a:defRPr sz="86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8468561" y="3056215"/>
            <a:ext cx="25923240" cy="20522565"/>
          </a:xfrm>
        </p:spPr>
        <p:txBody>
          <a:bodyPr rtlCol="0">
            <a:normAutofit/>
          </a:bodyPr>
          <a:lstStyle>
            <a:lvl1pPr marL="0" indent="0">
              <a:buNone/>
              <a:defRPr sz="13700"/>
            </a:lvl1pPr>
            <a:lvl2pPr marL="1954530" indent="0">
              <a:buNone/>
              <a:defRPr sz="12000"/>
            </a:lvl2pPr>
            <a:lvl3pPr marL="3909060" indent="0">
              <a:buNone/>
              <a:defRPr sz="10300"/>
            </a:lvl3pPr>
            <a:lvl4pPr marL="5863590" indent="0">
              <a:buNone/>
              <a:defRPr sz="8600"/>
            </a:lvl4pPr>
            <a:lvl5pPr marL="7818120" indent="0">
              <a:buNone/>
              <a:defRPr sz="8600"/>
            </a:lvl5pPr>
            <a:lvl6pPr marL="9772650" indent="0">
              <a:buNone/>
              <a:defRPr sz="8600"/>
            </a:lvl6pPr>
            <a:lvl7pPr marL="11727180" indent="0">
              <a:buNone/>
              <a:defRPr sz="8600"/>
            </a:lvl7pPr>
            <a:lvl8pPr marL="13681710" indent="0">
              <a:buNone/>
              <a:defRPr sz="8600"/>
            </a:lvl8pPr>
            <a:lvl9pPr marL="15636240" indent="0">
              <a:buNone/>
              <a:defRPr sz="86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468561" y="26769601"/>
            <a:ext cx="25923240" cy="4014249"/>
          </a:xfrm>
        </p:spPr>
        <p:txBody>
          <a:bodyPr/>
          <a:lstStyle>
            <a:lvl1pPr marL="0" indent="0">
              <a:buNone/>
              <a:defRPr sz="6000"/>
            </a:lvl1pPr>
            <a:lvl2pPr marL="1954530" indent="0">
              <a:buNone/>
              <a:defRPr sz="5100"/>
            </a:lvl2pPr>
            <a:lvl3pPr marL="3909060" indent="0">
              <a:buNone/>
              <a:defRPr sz="4300"/>
            </a:lvl3pPr>
            <a:lvl4pPr marL="5863590" indent="0">
              <a:buNone/>
              <a:defRPr sz="3800"/>
            </a:lvl4pPr>
            <a:lvl5pPr marL="7818120" indent="0">
              <a:buNone/>
              <a:defRPr sz="3800"/>
            </a:lvl5pPr>
            <a:lvl6pPr marL="9772650" indent="0">
              <a:buNone/>
              <a:defRPr sz="3800"/>
            </a:lvl6pPr>
            <a:lvl7pPr marL="11727180" indent="0">
              <a:buNone/>
              <a:defRPr sz="3800"/>
            </a:lvl7pPr>
            <a:lvl8pPr marL="13681710" indent="0">
              <a:buNone/>
              <a:defRPr sz="3800"/>
            </a:lvl8pPr>
            <a:lvl9pPr marL="15636240" indent="0">
              <a:buNone/>
              <a:defRPr sz="38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60B3B1-3954-45E4-826D-606B1CE60B41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B9BF2C-2C85-42AB-8B40-6806061FF4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2160588" y="1370013"/>
            <a:ext cx="38884225" cy="5700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390906" tIns="195453" rIns="390906" bIns="195453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2160588" y="7980363"/>
            <a:ext cx="38884225" cy="22574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390906" tIns="195453" rIns="390906" bIns="19545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2160588" y="31702375"/>
            <a:ext cx="10080625" cy="1820863"/>
          </a:xfrm>
          <a:prstGeom prst="rect">
            <a:avLst/>
          </a:prstGeom>
        </p:spPr>
        <p:txBody>
          <a:bodyPr vert="horz" lIns="390906" tIns="195453" rIns="390906" bIns="195453" rtlCol="0" anchor="ctr"/>
          <a:lstStyle>
            <a:lvl1pPr algn="l" defTabSz="3909060" fontAlgn="auto">
              <a:spcBef>
                <a:spcPts val="0"/>
              </a:spcBef>
              <a:spcAft>
                <a:spcPts val="0"/>
              </a:spcAft>
              <a:defRPr sz="51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DD7CF35-5C96-4401-926D-CECC3A4CE648}" type="datetimeFigureOut">
              <a:rPr lang="it-IT"/>
              <a:pPr>
                <a:defRPr/>
              </a:pPr>
              <a:t>27/02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4762163" y="31702375"/>
            <a:ext cx="13681075" cy="1820863"/>
          </a:xfrm>
          <a:prstGeom prst="rect">
            <a:avLst/>
          </a:prstGeom>
        </p:spPr>
        <p:txBody>
          <a:bodyPr vert="horz" lIns="390906" tIns="195453" rIns="390906" bIns="195453" rtlCol="0" anchor="ctr"/>
          <a:lstStyle>
            <a:lvl1pPr algn="ctr" defTabSz="3909060" fontAlgn="auto">
              <a:spcBef>
                <a:spcPts val="0"/>
              </a:spcBef>
              <a:spcAft>
                <a:spcPts val="0"/>
              </a:spcAft>
              <a:defRPr sz="51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30964188" y="31702375"/>
            <a:ext cx="10080625" cy="1820863"/>
          </a:xfrm>
          <a:prstGeom prst="rect">
            <a:avLst/>
          </a:prstGeom>
        </p:spPr>
        <p:txBody>
          <a:bodyPr vert="horz" lIns="390906" tIns="195453" rIns="390906" bIns="195453" rtlCol="0" anchor="ctr"/>
          <a:lstStyle>
            <a:lvl1pPr algn="r" defTabSz="3909060" fontAlgn="auto">
              <a:spcBef>
                <a:spcPts val="0"/>
              </a:spcBef>
              <a:spcAft>
                <a:spcPts val="0"/>
              </a:spcAft>
              <a:defRPr sz="51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AEDFDAE-7CEA-429A-BBF7-324A72511F0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908425" rtl="0" eaLnBrk="0" fontAlgn="base" hangingPunct="0">
        <a:spcBef>
          <a:spcPct val="0"/>
        </a:spcBef>
        <a:spcAft>
          <a:spcPct val="0"/>
        </a:spcAft>
        <a:defRPr sz="188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3908425" rtl="0" eaLnBrk="0" fontAlgn="base" hangingPunct="0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2pPr>
      <a:lvl3pPr algn="ctr" defTabSz="3908425" rtl="0" eaLnBrk="0" fontAlgn="base" hangingPunct="0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3pPr>
      <a:lvl4pPr algn="ctr" defTabSz="3908425" rtl="0" eaLnBrk="0" fontAlgn="base" hangingPunct="0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4pPr>
      <a:lvl5pPr algn="ctr" defTabSz="3908425" rtl="0" eaLnBrk="0" fontAlgn="base" hangingPunct="0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5pPr>
      <a:lvl6pPr marL="457200" algn="ctr" defTabSz="3908425" rtl="0" fontAlgn="base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6pPr>
      <a:lvl7pPr marL="914400" algn="ctr" defTabSz="3908425" rtl="0" fontAlgn="base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7pPr>
      <a:lvl8pPr marL="1371600" algn="ctr" defTabSz="3908425" rtl="0" fontAlgn="base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8pPr>
      <a:lvl9pPr marL="1828800" algn="ctr" defTabSz="3908425" rtl="0" fontAlgn="base">
        <a:spcBef>
          <a:spcPct val="0"/>
        </a:spcBef>
        <a:spcAft>
          <a:spcPct val="0"/>
        </a:spcAft>
        <a:defRPr sz="18800">
          <a:solidFill>
            <a:schemeClr val="tx1"/>
          </a:solidFill>
          <a:latin typeface="Calibri" pitchFamily="34" charset="0"/>
        </a:defRPr>
      </a:lvl9pPr>
    </p:titleStyle>
    <p:bodyStyle>
      <a:lvl1pPr marL="1465263" indent="-1465263" algn="l" defTabSz="39084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3700" kern="1200">
          <a:solidFill>
            <a:schemeClr val="tx1"/>
          </a:solidFill>
          <a:latin typeface="+mn-lt"/>
          <a:ea typeface="+mn-ea"/>
          <a:cs typeface="+mn-cs"/>
        </a:defRPr>
      </a:lvl1pPr>
      <a:lvl2pPr marL="3175000" indent="-1220788" algn="l" defTabSz="39084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2000" kern="1200">
          <a:solidFill>
            <a:schemeClr val="tx1"/>
          </a:solidFill>
          <a:latin typeface="+mn-lt"/>
          <a:ea typeface="+mn-ea"/>
          <a:cs typeface="+mn-cs"/>
        </a:defRPr>
      </a:lvl2pPr>
      <a:lvl3pPr marL="4886325" indent="-976313" algn="l" defTabSz="39084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0300" kern="1200">
          <a:solidFill>
            <a:schemeClr val="tx1"/>
          </a:solidFill>
          <a:latin typeface="+mn-lt"/>
          <a:ea typeface="+mn-ea"/>
          <a:cs typeface="+mn-cs"/>
        </a:defRPr>
      </a:lvl3pPr>
      <a:lvl4pPr marL="6840538" indent="-976313" algn="l" defTabSz="39084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8600" kern="1200">
          <a:solidFill>
            <a:schemeClr val="tx1"/>
          </a:solidFill>
          <a:latin typeface="+mn-lt"/>
          <a:ea typeface="+mn-ea"/>
          <a:cs typeface="+mn-cs"/>
        </a:defRPr>
      </a:lvl4pPr>
      <a:lvl5pPr marL="8794750" indent="-976313" algn="l" defTabSz="3908425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8600" kern="1200">
          <a:solidFill>
            <a:schemeClr val="tx1"/>
          </a:solidFill>
          <a:latin typeface="+mn-lt"/>
          <a:ea typeface="+mn-ea"/>
          <a:cs typeface="+mn-cs"/>
        </a:defRPr>
      </a:lvl5pPr>
      <a:lvl6pPr marL="10749915" indent="-977265" algn="l" defTabSz="3909060" rtl="0" eaLnBrk="1" latinLnBrk="0" hangingPunct="1">
        <a:spcBef>
          <a:spcPct val="20000"/>
        </a:spcBef>
        <a:buFont typeface="Arial" pitchFamily="34" charset="0"/>
        <a:buChar char="•"/>
        <a:defRPr sz="8600" kern="1200">
          <a:solidFill>
            <a:schemeClr val="tx1"/>
          </a:solidFill>
          <a:latin typeface="+mn-lt"/>
          <a:ea typeface="+mn-ea"/>
          <a:cs typeface="+mn-cs"/>
        </a:defRPr>
      </a:lvl6pPr>
      <a:lvl7pPr marL="12704445" indent="-977265" algn="l" defTabSz="3909060" rtl="0" eaLnBrk="1" latinLnBrk="0" hangingPunct="1">
        <a:spcBef>
          <a:spcPct val="20000"/>
        </a:spcBef>
        <a:buFont typeface="Arial" pitchFamily="34" charset="0"/>
        <a:buChar char="•"/>
        <a:defRPr sz="8600" kern="1200">
          <a:solidFill>
            <a:schemeClr val="tx1"/>
          </a:solidFill>
          <a:latin typeface="+mn-lt"/>
          <a:ea typeface="+mn-ea"/>
          <a:cs typeface="+mn-cs"/>
        </a:defRPr>
      </a:lvl7pPr>
      <a:lvl8pPr marL="14658975" indent="-977265" algn="l" defTabSz="3909060" rtl="0" eaLnBrk="1" latinLnBrk="0" hangingPunct="1">
        <a:spcBef>
          <a:spcPct val="20000"/>
        </a:spcBef>
        <a:buFont typeface="Arial" pitchFamily="34" charset="0"/>
        <a:buChar char="•"/>
        <a:defRPr sz="8600" kern="1200">
          <a:solidFill>
            <a:schemeClr val="tx1"/>
          </a:solidFill>
          <a:latin typeface="+mn-lt"/>
          <a:ea typeface="+mn-ea"/>
          <a:cs typeface="+mn-cs"/>
        </a:defRPr>
      </a:lvl8pPr>
      <a:lvl9pPr marL="16613505" indent="-977265" algn="l" defTabSz="3909060" rtl="0" eaLnBrk="1" latinLnBrk="0" hangingPunct="1">
        <a:spcBef>
          <a:spcPct val="20000"/>
        </a:spcBef>
        <a:buFont typeface="Arial" pitchFamily="34" charset="0"/>
        <a:buChar char="•"/>
        <a:defRPr sz="8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1pPr>
      <a:lvl2pPr marL="195453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2pPr>
      <a:lvl3pPr marL="390906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3pPr>
      <a:lvl4pPr marL="586359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4pPr>
      <a:lvl5pPr marL="781812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5pPr>
      <a:lvl6pPr marL="977265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6pPr>
      <a:lvl7pPr marL="1172718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7pPr>
      <a:lvl8pPr marL="1368171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8pPr>
      <a:lvl9pPr marL="15636240" algn="l" defTabSz="3909060" rtl="0" eaLnBrk="1" latinLnBrk="0" hangingPunct="1">
        <a:defRPr sz="7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CasellaDiTesto 3"/>
          <p:cNvSpPr txBox="1">
            <a:spLocks noChangeArrowheads="1"/>
          </p:cNvSpPr>
          <p:nvPr/>
        </p:nvSpPr>
        <p:spPr bwMode="auto">
          <a:xfrm>
            <a:off x="215900" y="100013"/>
            <a:ext cx="16314738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6000" b="1" dirty="0"/>
              <a:t>Supplementary</a:t>
            </a:r>
            <a:r>
              <a:rPr lang="it-IT" sz="6000" b="1" dirty="0"/>
              <a:t> Figure S1</a:t>
            </a:r>
          </a:p>
        </p:txBody>
      </p:sp>
      <p:sp>
        <p:nvSpPr>
          <p:cNvPr id="2051" name="CasellaDiTesto 12"/>
          <p:cNvSpPr txBox="1">
            <a:spLocks noChangeArrowheads="1"/>
          </p:cNvSpPr>
          <p:nvPr/>
        </p:nvSpPr>
        <p:spPr bwMode="auto">
          <a:xfrm>
            <a:off x="576263" y="1252538"/>
            <a:ext cx="180022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0" b="1" dirty="0"/>
              <a:t>a</a:t>
            </a:r>
          </a:p>
        </p:txBody>
      </p:sp>
      <p:pic>
        <p:nvPicPr>
          <p:cNvPr id="2052" name="Picture 18" descr="C:\Users\utente\Desktop\CD34 methylation analysis\06Aug2021\CD34_TSSPM_mds_Time_Patient_02Aug2021b.png"/>
          <p:cNvPicPr>
            <a:picLocks noChangeAspect="1" noChangeArrowheads="1"/>
          </p:cNvPicPr>
          <p:nvPr/>
        </p:nvPicPr>
        <p:blipFill>
          <a:blip r:embed="rId2"/>
          <a:srcRect l="835" t="15002" r="8334" b="4877"/>
          <a:stretch>
            <a:fillRect/>
          </a:stretch>
        </p:blipFill>
        <p:spPr bwMode="auto">
          <a:xfrm>
            <a:off x="1008063" y="2702297"/>
            <a:ext cx="11836400" cy="1043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3" name="Picture 19" descr="C:\Users\utente\Desktop\CD34 methylation analysis\06Aug2021\CD34_TSSPM_mds_Disease_CHIP_02Aug2021b.png"/>
          <p:cNvPicPr>
            <a:picLocks noChangeAspect="1" noChangeArrowheads="1"/>
          </p:cNvPicPr>
          <p:nvPr/>
        </p:nvPicPr>
        <p:blipFill>
          <a:blip r:embed="rId3"/>
          <a:srcRect t="15002" r="5835" b="3334"/>
          <a:stretch>
            <a:fillRect/>
          </a:stretch>
        </p:blipFill>
        <p:spPr bwMode="auto">
          <a:xfrm>
            <a:off x="13669143" y="2702297"/>
            <a:ext cx="12038013" cy="1043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4" name="CasellaDiTesto 12"/>
          <p:cNvSpPr txBox="1">
            <a:spLocks noChangeArrowheads="1"/>
          </p:cNvSpPr>
          <p:nvPr/>
        </p:nvSpPr>
        <p:spPr bwMode="auto">
          <a:xfrm>
            <a:off x="13669143" y="1252538"/>
            <a:ext cx="180022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0" b="1" dirty="0"/>
              <a:t>b</a:t>
            </a:r>
          </a:p>
        </p:txBody>
      </p:sp>
      <p:sp>
        <p:nvSpPr>
          <p:cNvPr id="2" name="CasellaDiTesto 13">
            <a:extLst>
              <a:ext uri="{FF2B5EF4-FFF2-40B4-BE49-F238E27FC236}">
                <a16:creationId xmlns:a16="http://schemas.microsoft.com/office/drawing/2014/main" id="{E1331A0B-6EA8-D9C2-6A90-846E42CEA8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263" y="13832266"/>
            <a:ext cx="2205093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it-IT" altLang="it-IT" sz="6000" b="1" dirty="0"/>
              <a:t>c</a:t>
            </a:r>
          </a:p>
        </p:txBody>
      </p:sp>
      <p:sp>
        <p:nvSpPr>
          <p:cNvPr id="3" name="CasellaDiTesto 14">
            <a:extLst>
              <a:ext uri="{FF2B5EF4-FFF2-40B4-BE49-F238E27FC236}">
                <a16:creationId xmlns:a16="http://schemas.microsoft.com/office/drawing/2014/main" id="{9493ABE1-9EAD-7267-DA52-17DD27E190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69143" y="13832266"/>
            <a:ext cx="2207037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it-IT" altLang="it-IT" sz="6000" b="1" dirty="0"/>
              <a:t>d</a:t>
            </a:r>
          </a:p>
        </p:txBody>
      </p:sp>
      <p:grpSp>
        <p:nvGrpSpPr>
          <p:cNvPr id="4" name="Gruppo 18">
            <a:extLst>
              <a:ext uri="{FF2B5EF4-FFF2-40B4-BE49-F238E27FC236}">
                <a16:creationId xmlns:a16="http://schemas.microsoft.com/office/drawing/2014/main" id="{A0E4728F-A4F1-EBC1-D168-0D4726BBC286}"/>
              </a:ext>
            </a:extLst>
          </p:cNvPr>
          <p:cNvGrpSpPr>
            <a:grpSpLocks/>
          </p:cNvGrpSpPr>
          <p:nvPr/>
        </p:nvGrpSpPr>
        <p:grpSpPr bwMode="auto">
          <a:xfrm>
            <a:off x="1251299" y="15451973"/>
            <a:ext cx="11195313" cy="9192243"/>
            <a:chOff x="22001818" y="15733985"/>
            <a:chExt cx="11050154" cy="9073008"/>
          </a:xfrm>
        </p:grpSpPr>
        <p:pic>
          <p:nvPicPr>
            <p:cNvPr id="5" name="Immagine 6">
              <a:extLst>
                <a:ext uri="{FF2B5EF4-FFF2-40B4-BE49-F238E27FC236}">
                  <a16:creationId xmlns:a16="http://schemas.microsoft.com/office/drawing/2014/main" id="{63A7503F-67C5-A06F-13DD-5E70F97F57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485" t="11256" r="4825" b="8833"/>
            <a:stretch>
              <a:fillRect/>
            </a:stretch>
          </p:blipFill>
          <p:spPr bwMode="auto">
            <a:xfrm>
              <a:off x="22754828" y="15733985"/>
              <a:ext cx="10297144" cy="9073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CasellaDiTesto 16">
              <a:extLst>
                <a:ext uri="{FF2B5EF4-FFF2-40B4-BE49-F238E27FC236}">
                  <a16:creationId xmlns:a16="http://schemas.microsoft.com/office/drawing/2014/main" id="{AF162CFA-54C5-75DE-3074-1F1C0520DB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18515939" y="19579903"/>
              <a:ext cx="7829706" cy="8579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it-IT" altLang="it-IT" sz="4400"/>
                <a:t>Methylation </a:t>
              </a:r>
              <a:r>
                <a:rPr lang="it-IT" altLang="it-IT" sz="4000"/>
                <a:t>level</a:t>
              </a:r>
              <a:r>
                <a:rPr lang="it-IT" altLang="it-IT" sz="4400"/>
                <a:t> (</a:t>
              </a:r>
              <a:r>
                <a:rPr lang="el-GR" altLang="it-IT" sz="4400"/>
                <a:t>β</a:t>
              </a:r>
              <a:r>
                <a:rPr lang="it-IT" altLang="it-IT" sz="4400"/>
                <a:t>-value)</a:t>
              </a:r>
            </a:p>
          </p:txBody>
        </p:sp>
      </p:grpSp>
      <p:grpSp>
        <p:nvGrpSpPr>
          <p:cNvPr id="7" name="Gruppo 19">
            <a:extLst>
              <a:ext uri="{FF2B5EF4-FFF2-40B4-BE49-F238E27FC236}">
                <a16:creationId xmlns:a16="http://schemas.microsoft.com/office/drawing/2014/main" id="{B06C08BB-76FA-9605-415E-1798A7A2DEB7}"/>
              </a:ext>
            </a:extLst>
          </p:cNvPr>
          <p:cNvGrpSpPr>
            <a:grpSpLocks/>
          </p:cNvGrpSpPr>
          <p:nvPr/>
        </p:nvGrpSpPr>
        <p:grpSpPr bwMode="auto">
          <a:xfrm>
            <a:off x="14545917" y="15453766"/>
            <a:ext cx="11161240" cy="9190450"/>
            <a:chOff x="22036135" y="25023017"/>
            <a:chExt cx="11015837" cy="9072000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035B7365-6982-4097-B3D0-6D10208929E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4526" t="12556" r="5486" b="7047"/>
            <a:stretch>
              <a:fillRect/>
            </a:stretch>
          </p:blipFill>
          <p:spPr bwMode="auto">
            <a:xfrm>
              <a:off x="22898844" y="25023017"/>
              <a:ext cx="10153128" cy="907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CasellaDiTesto 17">
              <a:extLst>
                <a:ext uri="{FF2B5EF4-FFF2-40B4-BE49-F238E27FC236}">
                  <a16:creationId xmlns:a16="http://schemas.microsoft.com/office/drawing/2014/main" id="{86DA7540-7959-6AAD-FCA4-273D8FDE2B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18794387" y="28624804"/>
              <a:ext cx="7272808" cy="789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1" hangingPunct="1"/>
              <a:r>
                <a:rPr lang="it-IT" altLang="it-IT" sz="4000"/>
                <a:t>Methylation level (</a:t>
              </a:r>
              <a:r>
                <a:rPr lang="el-GR" altLang="it-IT" sz="4000"/>
                <a:t>β</a:t>
              </a:r>
              <a:r>
                <a:rPr lang="it-IT" altLang="it-IT" sz="4000"/>
                <a:t>-value)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153524F-50FE-6300-33EA-26E891AF1C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00013"/>
            <a:ext cx="16314738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6000" b="1" dirty="0"/>
              <a:t>Supplementary</a:t>
            </a:r>
            <a:r>
              <a:rPr lang="it-IT" sz="6000" b="1" dirty="0"/>
              <a:t> Figure S2</a:t>
            </a:r>
          </a:p>
        </p:txBody>
      </p:sp>
      <p:pic>
        <p:nvPicPr>
          <p:cNvPr id="7" name="Immagine 4">
            <a:extLst>
              <a:ext uri="{FF2B5EF4-FFF2-40B4-BE49-F238E27FC236}">
                <a16:creationId xmlns:a16="http://schemas.microsoft.com/office/drawing/2014/main" id="{0EEE1944-7942-C188-4660-024D9AF39DCC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92"/>
          <a:stretch>
            <a:fillRect/>
          </a:stretch>
        </p:blipFill>
        <p:spPr bwMode="auto">
          <a:xfrm>
            <a:off x="1496419" y="2361525"/>
            <a:ext cx="7238408" cy="9283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asellaDiTesto 12">
            <a:extLst>
              <a:ext uri="{FF2B5EF4-FFF2-40B4-BE49-F238E27FC236}">
                <a16:creationId xmlns:a16="http://schemas.microsoft.com/office/drawing/2014/main" id="{1584B0A9-BB06-E3EE-8A03-BF19AED3B5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828" y="1345525"/>
            <a:ext cx="180022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0" b="1" dirty="0"/>
              <a:t>a</a:t>
            </a:r>
          </a:p>
        </p:txBody>
      </p:sp>
      <p:sp>
        <p:nvSpPr>
          <p:cNvPr id="3" name="CasellaDiTesto 12">
            <a:extLst>
              <a:ext uri="{FF2B5EF4-FFF2-40B4-BE49-F238E27FC236}">
                <a16:creationId xmlns:a16="http://schemas.microsoft.com/office/drawing/2014/main" id="{8433CB2B-48DD-8011-67ED-F58B1F6726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24727" y="1345525"/>
            <a:ext cx="180022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0" b="1" dirty="0"/>
              <a:t>b</a:t>
            </a:r>
          </a:p>
        </p:txBody>
      </p:sp>
      <p:pic>
        <p:nvPicPr>
          <p:cNvPr id="6" name="Immagine 2">
            <a:extLst>
              <a:ext uri="{FF2B5EF4-FFF2-40B4-BE49-F238E27FC236}">
                <a16:creationId xmlns:a16="http://schemas.microsoft.com/office/drawing/2014/main" id="{5E031A77-BA15-6699-114A-EFEB6BD5878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801500" y="3348609"/>
            <a:ext cx="31755528" cy="60437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001601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ttangolo 7"/>
          <p:cNvSpPr>
            <a:spLocks noChangeArrowheads="1"/>
          </p:cNvSpPr>
          <p:nvPr/>
        </p:nvSpPr>
        <p:spPr bwMode="auto">
          <a:xfrm rot="10800000" flipV="1">
            <a:off x="7289220" y="3903775"/>
            <a:ext cx="27083518" cy="7694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4400" b="1"/>
              <a:t>Hypo-methylated genes in T1 vs T0 </a:t>
            </a:r>
            <a:endParaRPr lang="it-IT" sz="4400" b="1"/>
          </a:p>
        </p:txBody>
      </p:sp>
      <p:grpSp>
        <p:nvGrpSpPr>
          <p:cNvPr id="6" name="Gruppo 5">
            <a:extLst>
              <a:ext uri="{FF2B5EF4-FFF2-40B4-BE49-F238E27FC236}">
                <a16:creationId xmlns:a16="http://schemas.microsoft.com/office/drawing/2014/main" id="{1FCC842D-B40A-06A9-C38F-0A2CE64180C4}"/>
              </a:ext>
            </a:extLst>
          </p:cNvPr>
          <p:cNvGrpSpPr/>
          <p:nvPr/>
        </p:nvGrpSpPr>
        <p:grpSpPr>
          <a:xfrm>
            <a:off x="7289221" y="5157688"/>
            <a:ext cx="13762038" cy="10390845"/>
            <a:chOff x="13753828" y="3354213"/>
            <a:chExt cx="13762038" cy="10390845"/>
          </a:xfrm>
        </p:grpSpPr>
        <p:sp>
          <p:nvSpPr>
            <p:cNvPr id="4098" name="CasellaDiTesto 22"/>
            <p:cNvSpPr txBox="1">
              <a:spLocks noChangeArrowheads="1"/>
            </p:cNvSpPr>
            <p:nvPr/>
          </p:nvSpPr>
          <p:spPr bwMode="auto">
            <a:xfrm>
              <a:off x="18493666" y="3354213"/>
              <a:ext cx="6925457" cy="769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Pathway </a:t>
              </a:r>
              <a:r>
                <a:rPr lang="it-IT" sz="4400" b="1" dirty="0" err="1"/>
                <a:t>analysis</a:t>
              </a:r>
              <a:endParaRPr lang="it-IT" sz="4400" b="1" dirty="0"/>
            </a:p>
          </p:txBody>
        </p:sp>
        <p:pic>
          <p:nvPicPr>
            <p:cNvPr id="4101" name="Immagine 3"/>
            <p:cNvPicPr>
              <a:picLocks noChangeAspect="1"/>
            </p:cNvPicPr>
            <p:nvPr/>
          </p:nvPicPr>
          <p:blipFill>
            <a:blip r:embed="rId2"/>
            <a:srcRect l="684" t="5769" b="835"/>
            <a:stretch>
              <a:fillRect/>
            </a:stretch>
          </p:blipFill>
          <p:spPr bwMode="auto">
            <a:xfrm>
              <a:off x="13753828" y="4039083"/>
              <a:ext cx="13762038" cy="9705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D63984D1-AD3F-0185-D0FA-9482001860F6}"/>
              </a:ext>
            </a:extLst>
          </p:cNvPr>
          <p:cNvGrpSpPr/>
          <p:nvPr/>
        </p:nvGrpSpPr>
        <p:grpSpPr>
          <a:xfrm>
            <a:off x="21106002" y="5179489"/>
            <a:ext cx="13266737" cy="10030906"/>
            <a:chOff x="27401566" y="3376014"/>
            <a:chExt cx="13266737" cy="10030906"/>
          </a:xfrm>
        </p:grpSpPr>
        <p:sp>
          <p:nvSpPr>
            <p:cNvPr id="4100" name="CasellaDiTesto 24"/>
            <p:cNvSpPr txBox="1">
              <a:spLocks noChangeArrowheads="1"/>
            </p:cNvSpPr>
            <p:nvPr/>
          </p:nvSpPr>
          <p:spPr bwMode="auto">
            <a:xfrm>
              <a:off x="31721498" y="3376014"/>
              <a:ext cx="7345363" cy="769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it-IT" sz="4400" b="1" dirty="0" err="1"/>
                <a:t>Immunological</a:t>
              </a:r>
              <a:r>
                <a:rPr lang="it-IT" sz="4400" b="1" dirty="0"/>
                <a:t> signature</a:t>
              </a:r>
            </a:p>
          </p:txBody>
        </p:sp>
        <p:pic>
          <p:nvPicPr>
            <p:cNvPr id="4102" name="Immagine 4"/>
            <p:cNvPicPr>
              <a:picLocks noChangeAspect="1"/>
            </p:cNvPicPr>
            <p:nvPr/>
          </p:nvPicPr>
          <p:blipFill>
            <a:blip r:embed="rId3"/>
            <a:srcRect t="5835"/>
            <a:stretch>
              <a:fillRect/>
            </a:stretch>
          </p:blipFill>
          <p:spPr bwMode="auto">
            <a:xfrm>
              <a:off x="27401566" y="4039083"/>
              <a:ext cx="13266737" cy="93678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4103" name="CasellaDiTesto 3"/>
          <p:cNvSpPr txBox="1">
            <a:spLocks noChangeArrowheads="1"/>
          </p:cNvSpPr>
          <p:nvPr/>
        </p:nvSpPr>
        <p:spPr bwMode="auto">
          <a:xfrm>
            <a:off x="215900" y="100013"/>
            <a:ext cx="9721850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6000" b="1" dirty="0"/>
              <a:t>Supplementary</a:t>
            </a:r>
            <a:r>
              <a:rPr lang="it-IT" sz="6000" b="1" dirty="0"/>
              <a:t> Figure S3</a:t>
            </a:r>
          </a:p>
        </p:txBody>
      </p:sp>
      <p:sp>
        <p:nvSpPr>
          <p:cNvPr id="2" name="CasellaDiTesto 12">
            <a:extLst>
              <a:ext uri="{FF2B5EF4-FFF2-40B4-BE49-F238E27FC236}">
                <a16:creationId xmlns:a16="http://schemas.microsoft.com/office/drawing/2014/main" id="{D15451A6-E5FB-2259-83FE-BD225ECD0D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89107" y="3514556"/>
            <a:ext cx="180022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0" b="1" dirty="0"/>
              <a:t>a</a:t>
            </a:r>
          </a:p>
        </p:txBody>
      </p:sp>
      <p:sp>
        <p:nvSpPr>
          <p:cNvPr id="4" name="CasellaDiTesto 13">
            <a:extLst>
              <a:ext uri="{FF2B5EF4-FFF2-40B4-BE49-F238E27FC236}">
                <a16:creationId xmlns:a16="http://schemas.microsoft.com/office/drawing/2014/main" id="{A672AC44-5703-2F29-A4B9-EA15E10750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7167402"/>
            <a:ext cx="2205093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it-IT" altLang="it-IT" sz="6000" b="1" dirty="0"/>
              <a:t>b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4B08EF9D-F754-DED7-F259-B423EC960F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9220" y="19875674"/>
            <a:ext cx="5113338" cy="769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4400" b="1" dirty="0"/>
              <a:t>Gene </a:t>
            </a:r>
            <a:r>
              <a:rPr lang="it-IT" sz="4400" b="1" dirty="0" err="1"/>
              <a:t>ontology</a:t>
            </a:r>
            <a:endParaRPr lang="it-IT" sz="4400" b="1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25017E1-E6D4-A908-6FAC-04D68B2053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59220" y="19875674"/>
            <a:ext cx="5113338" cy="769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4400" b="1" dirty="0"/>
              <a:t>Pathway </a:t>
            </a:r>
            <a:r>
              <a:rPr lang="it-IT" sz="4400" b="1" dirty="0" err="1"/>
              <a:t>analysis</a:t>
            </a:r>
            <a:endParaRPr lang="it-IT" sz="4400" b="1" dirty="0"/>
          </a:p>
        </p:txBody>
      </p:sp>
      <p:sp>
        <p:nvSpPr>
          <p:cNvPr id="9" name="Rettangolo 7">
            <a:extLst>
              <a:ext uri="{FF2B5EF4-FFF2-40B4-BE49-F238E27FC236}">
                <a16:creationId xmlns:a16="http://schemas.microsoft.com/office/drawing/2014/main" id="{F6307EFF-1D76-4A39-AED3-D1879259853F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1800499" y="18521785"/>
            <a:ext cx="40972552" cy="769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4400" b="1" dirty="0"/>
              <a:t>Hyper-methylated “stable” genes in T4</a:t>
            </a:r>
            <a:endParaRPr lang="it-IT" sz="4400" b="1" dirty="0"/>
          </a:p>
        </p:txBody>
      </p:sp>
      <p:sp>
        <p:nvSpPr>
          <p:cNvPr id="10" name="CasellaDiTesto 10">
            <a:extLst>
              <a:ext uri="{FF2B5EF4-FFF2-40B4-BE49-F238E27FC236}">
                <a16:creationId xmlns:a16="http://schemas.microsoft.com/office/drawing/2014/main" id="{EABCBF13-363A-7C1A-536D-B28C883628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91255" y="19715337"/>
            <a:ext cx="7343775" cy="769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4400" b="1" dirty="0" err="1"/>
              <a:t>Immunological</a:t>
            </a:r>
            <a:r>
              <a:rPr lang="it-IT" sz="4400" b="1" dirty="0"/>
              <a:t> signature</a:t>
            </a:r>
          </a:p>
        </p:txBody>
      </p:sp>
      <p:pic>
        <p:nvPicPr>
          <p:cNvPr id="11" name="Immagine 1">
            <a:extLst>
              <a:ext uri="{FF2B5EF4-FFF2-40B4-BE49-F238E27FC236}">
                <a16:creationId xmlns:a16="http://schemas.microsoft.com/office/drawing/2014/main" id="{BD6AE623-1EB3-F323-EAD7-BA14B8B965F1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t="5695" b="835"/>
          <a:stretch>
            <a:fillRect/>
          </a:stretch>
        </p:blipFill>
        <p:spPr bwMode="auto">
          <a:xfrm>
            <a:off x="-9770" y="20645612"/>
            <a:ext cx="14662150" cy="1027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Immagine 2">
            <a:extLst>
              <a:ext uri="{FF2B5EF4-FFF2-40B4-BE49-F238E27FC236}">
                <a16:creationId xmlns:a16="http://schemas.microsoft.com/office/drawing/2014/main" id="{0D145706-72E4-E411-BA7A-CC1CE6D0E7A9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t="5682" b="835"/>
          <a:stretch>
            <a:fillRect/>
          </a:stretch>
        </p:blipFill>
        <p:spPr bwMode="auto">
          <a:xfrm>
            <a:off x="14365043" y="20572587"/>
            <a:ext cx="14660562" cy="1027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Immagine 3">
            <a:extLst>
              <a:ext uri="{FF2B5EF4-FFF2-40B4-BE49-F238E27FC236}">
                <a16:creationId xmlns:a16="http://schemas.microsoft.com/office/drawing/2014/main" id="{8576026C-7A5D-2821-A1E9-D38328CBC20E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t="5585"/>
          <a:stretch>
            <a:fillRect/>
          </a:stretch>
        </p:blipFill>
        <p:spPr bwMode="auto">
          <a:xfrm>
            <a:off x="28622380" y="20501150"/>
            <a:ext cx="14644688" cy="1036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5661B5C0-4AA9-8F86-BBB2-24D5DBF116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00013"/>
            <a:ext cx="13898563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6000" b="1" dirty="0"/>
              <a:t>Supplementary</a:t>
            </a:r>
            <a:r>
              <a:rPr lang="it-IT" sz="6000" b="1" dirty="0"/>
              <a:t> Figure S4</a:t>
            </a:r>
          </a:p>
        </p:txBody>
      </p:sp>
      <p:sp>
        <p:nvSpPr>
          <p:cNvPr id="5" name="Rettangolo 7">
            <a:extLst>
              <a:ext uri="{FF2B5EF4-FFF2-40B4-BE49-F238E27FC236}">
                <a16:creationId xmlns:a16="http://schemas.microsoft.com/office/drawing/2014/main" id="{E556BFDC-D43E-7C9F-5502-C58D658A031E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4780911" y="1216681"/>
            <a:ext cx="16129000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it-IT" sz="4400" b="1" dirty="0"/>
              <a:t>Hyper-methylated genes in P14 T4 vs all other T4</a:t>
            </a:r>
            <a:endParaRPr lang="it-IT" altLang="it-IT" sz="4400" b="1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AA6A01A-0325-3598-0504-73018E8F36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0686" y="1216680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a</a:t>
            </a: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F5FBA8BC-002F-C19E-5CB1-D2602D575F76}"/>
              </a:ext>
            </a:extLst>
          </p:cNvPr>
          <p:cNvGrpSpPr/>
          <p:nvPr/>
        </p:nvGrpSpPr>
        <p:grpSpPr>
          <a:xfrm>
            <a:off x="5111928" y="1908450"/>
            <a:ext cx="13672836" cy="10394071"/>
            <a:chOff x="2995613" y="3226744"/>
            <a:chExt cx="16208420" cy="12321618"/>
          </a:xfrm>
        </p:grpSpPr>
        <p:pic>
          <p:nvPicPr>
            <p:cNvPr id="7" name="Picture 22" descr="C:\Users\utente\Desktop\CD34 methylation analysis\09June2022\PZ14 T4\CD34_TSSPM_09June2022_Enrich_PZ14_t4_Hyper_c5.png">
              <a:extLst>
                <a:ext uri="{FF2B5EF4-FFF2-40B4-BE49-F238E27FC236}">
                  <a16:creationId xmlns:a16="http://schemas.microsoft.com/office/drawing/2014/main" id="{D27691D8-CD50-AE79-6B4B-903B4BB70B2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7" t="6519" r="1788" b="1199"/>
            <a:stretch>
              <a:fillRect/>
            </a:stretch>
          </p:blipFill>
          <p:spPr bwMode="auto">
            <a:xfrm>
              <a:off x="2995613" y="4033217"/>
              <a:ext cx="16208420" cy="11515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CasellaDiTesto 6">
              <a:extLst>
                <a:ext uri="{FF2B5EF4-FFF2-40B4-BE49-F238E27FC236}">
                  <a16:creationId xmlns:a16="http://schemas.microsoft.com/office/drawing/2014/main" id="{674C52BF-9FA1-EA74-99F3-055DC809DD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77164" y="3226744"/>
              <a:ext cx="9289032" cy="769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it-IT" altLang="it-IT" sz="4400" b="1" dirty="0"/>
                <a:t>Gene </a:t>
              </a:r>
              <a:r>
                <a:rPr lang="it-IT" altLang="it-IT" sz="4400" b="1" dirty="0" err="1"/>
                <a:t>ontology</a:t>
              </a:r>
              <a:endParaRPr lang="it-IT" altLang="it-IT" sz="4400" b="1" dirty="0"/>
            </a:p>
          </p:txBody>
        </p:sp>
      </p:grpSp>
      <p:sp>
        <p:nvSpPr>
          <p:cNvPr id="9" name="Rettangolo 7">
            <a:extLst>
              <a:ext uri="{FF2B5EF4-FFF2-40B4-BE49-F238E27FC236}">
                <a16:creationId xmlns:a16="http://schemas.microsoft.com/office/drawing/2014/main" id="{6FFBC763-F1BE-F319-73BB-3F9A628E46D1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23979756" y="1216681"/>
            <a:ext cx="16129000" cy="769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it-IT" sz="4400" b="1" dirty="0"/>
              <a:t>Hypo-methylated genes in P14 T4 vs all other T4</a:t>
            </a:r>
            <a:endParaRPr lang="it-IT" altLang="it-IT" sz="4400" b="1" dirty="0"/>
          </a:p>
        </p:txBody>
      </p:sp>
      <p:sp>
        <p:nvSpPr>
          <p:cNvPr id="11" name="CasellaDiTesto 5">
            <a:extLst>
              <a:ext uri="{FF2B5EF4-FFF2-40B4-BE49-F238E27FC236}">
                <a16:creationId xmlns:a16="http://schemas.microsoft.com/office/drawing/2014/main" id="{9DDCFB8D-9995-0A1F-FE87-B57BB1F8EE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27086" y="1216680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b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75516500-E135-1161-C3A7-4DCE51DAEF91}"/>
              </a:ext>
            </a:extLst>
          </p:cNvPr>
          <p:cNvGrpSpPr/>
          <p:nvPr/>
        </p:nvGrpSpPr>
        <p:grpSpPr>
          <a:xfrm>
            <a:off x="25719656" y="2079082"/>
            <a:ext cx="13623010" cy="10455724"/>
            <a:chOff x="25790872" y="4992065"/>
            <a:chExt cx="14136642" cy="10849939"/>
          </a:xfrm>
        </p:grpSpPr>
        <p:sp>
          <p:nvSpPr>
            <p:cNvPr id="10" name="CasellaDiTesto 6">
              <a:extLst>
                <a:ext uri="{FF2B5EF4-FFF2-40B4-BE49-F238E27FC236}">
                  <a16:creationId xmlns:a16="http://schemas.microsoft.com/office/drawing/2014/main" id="{7C64AF94-705A-6F53-2AEB-1BA910BD33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595588" y="4992065"/>
              <a:ext cx="8568952" cy="7699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it-IT" altLang="it-IT" sz="4400" b="1"/>
                <a:t>Gene ontology</a:t>
              </a:r>
            </a:p>
          </p:txBody>
        </p:sp>
        <p:pic>
          <p:nvPicPr>
            <p:cNvPr id="12" name="Picture 24" descr="C:\Users\utente\Desktop\CD34 methylation analysis\09June2022\PZ14 T4\CD34_TSSPM_09June2022_Enrich_PZ14_t4_Hypo_c5.png">
              <a:extLst>
                <a:ext uri="{FF2B5EF4-FFF2-40B4-BE49-F238E27FC236}">
                  <a16:creationId xmlns:a16="http://schemas.microsoft.com/office/drawing/2014/main" id="{2EEBACD9-B9B0-AD4A-8CA8-5A7F8963BEE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" t="6519" r="2188" b="1067"/>
            <a:stretch>
              <a:fillRect/>
            </a:stretch>
          </p:blipFill>
          <p:spPr bwMode="auto">
            <a:xfrm>
              <a:off x="25790872" y="5762004"/>
              <a:ext cx="14136642" cy="100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3" name="Rettangolo 7">
            <a:extLst>
              <a:ext uri="{FF2B5EF4-FFF2-40B4-BE49-F238E27FC236}">
                <a16:creationId xmlns:a16="http://schemas.microsoft.com/office/drawing/2014/main" id="{06E86C1C-CE69-0036-A3B7-5D95AAE36AA4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6637856" y="12822855"/>
            <a:ext cx="28544110" cy="7694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4400" b="1" dirty="0"/>
              <a:t>Hyper-methylated genes in T1 P14 vs other patients</a:t>
            </a:r>
            <a:endParaRPr lang="it-IT" sz="4400" b="1" dirty="0"/>
          </a:p>
        </p:txBody>
      </p: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3B0082CB-386E-BB01-623F-74840BE06DE0}"/>
              </a:ext>
            </a:extLst>
          </p:cNvPr>
          <p:cNvGrpSpPr/>
          <p:nvPr/>
        </p:nvGrpSpPr>
        <p:grpSpPr>
          <a:xfrm>
            <a:off x="6871689" y="13504876"/>
            <a:ext cx="13580111" cy="10529153"/>
            <a:chOff x="785813" y="2501901"/>
            <a:chExt cx="14092126" cy="10926137"/>
          </a:xfrm>
        </p:grpSpPr>
        <p:sp>
          <p:nvSpPr>
            <p:cNvPr id="15" name="CasellaDiTesto 6">
              <a:extLst>
                <a:ext uri="{FF2B5EF4-FFF2-40B4-BE49-F238E27FC236}">
                  <a16:creationId xmlns:a16="http://schemas.microsoft.com/office/drawing/2014/main" id="{2529E369-5AA3-BF2B-F419-161298D8A5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10150" y="2501901"/>
              <a:ext cx="8023598" cy="769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Gene </a:t>
              </a:r>
              <a:r>
                <a:rPr lang="it-IT" sz="4400" b="1" dirty="0" err="1"/>
                <a:t>ontology</a:t>
              </a:r>
              <a:endParaRPr lang="it-IT" sz="4400" b="1" dirty="0"/>
            </a:p>
          </p:txBody>
        </p:sp>
        <p:pic>
          <p:nvPicPr>
            <p:cNvPr id="16" name="Picture 2" descr="C:\Users\utente\Desktop\CD34 methylation analysis\09June2022\PZ14 T1\CD34_TSSPM_09June2022_Enrich_PZ14_t1_Hyper_c5.png">
              <a:extLst>
                <a:ext uri="{FF2B5EF4-FFF2-40B4-BE49-F238E27FC236}">
                  <a16:creationId xmlns:a16="http://schemas.microsoft.com/office/drawing/2014/main" id="{8A3C9446-7C85-815E-353F-B45ADDDD37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/>
            <a:srcRect t="6519" r="1988"/>
            <a:stretch>
              <a:fillRect/>
            </a:stretch>
          </p:blipFill>
          <p:spPr bwMode="auto">
            <a:xfrm>
              <a:off x="785813" y="3348038"/>
              <a:ext cx="14092126" cy="10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C3764925-69AB-D1DF-D713-BFFF253FEF36}"/>
              </a:ext>
            </a:extLst>
          </p:cNvPr>
          <p:cNvGrpSpPr/>
          <p:nvPr/>
        </p:nvGrpSpPr>
        <p:grpSpPr>
          <a:xfrm>
            <a:off x="21095842" y="13515657"/>
            <a:ext cx="13607662" cy="10521284"/>
            <a:chOff x="15481300" y="2527529"/>
            <a:chExt cx="14120716" cy="10917971"/>
          </a:xfrm>
        </p:grpSpPr>
        <p:sp>
          <p:nvSpPr>
            <p:cNvPr id="18" name="CasellaDiTesto 7">
              <a:extLst>
                <a:ext uri="{FF2B5EF4-FFF2-40B4-BE49-F238E27FC236}">
                  <a16:creationId xmlns:a16="http://schemas.microsoft.com/office/drawing/2014/main" id="{5BCB2082-8933-0195-2392-BB99FD0954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226436" y="2527529"/>
              <a:ext cx="8352928" cy="769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Pathway </a:t>
              </a:r>
              <a:r>
                <a:rPr lang="it-IT" sz="4400" b="1" dirty="0" err="1"/>
                <a:t>analysis</a:t>
              </a:r>
              <a:endParaRPr lang="it-IT" sz="4400" b="1" dirty="0"/>
            </a:p>
          </p:txBody>
        </p:sp>
        <p:pic>
          <p:nvPicPr>
            <p:cNvPr id="19" name="Picture 3" descr="C:\Users\utente\Desktop\CD34 methylation analysis\09June2022\PZ14 T1\CD34_TSSPM_09June2022_Enrich_PZ14_t1_Hyper_c2.png">
              <a:extLst>
                <a:ext uri="{FF2B5EF4-FFF2-40B4-BE49-F238E27FC236}">
                  <a16:creationId xmlns:a16="http://schemas.microsoft.com/office/drawing/2014/main" id="{E61C7960-A495-3FB4-9CE9-6FDAB1A69B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/>
            <a:srcRect t="6519" r="1788"/>
            <a:stretch>
              <a:fillRect/>
            </a:stretch>
          </p:blipFill>
          <p:spPr bwMode="auto">
            <a:xfrm>
              <a:off x="15481300" y="3365500"/>
              <a:ext cx="14120716" cy="10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DD2A677E-4F51-EEA2-2D0C-803101FD0D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11815" y="12576297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c</a:t>
            </a:r>
          </a:p>
        </p:txBody>
      </p:sp>
      <p:sp>
        <p:nvSpPr>
          <p:cNvPr id="21" name="Rettangolo 7">
            <a:extLst>
              <a:ext uri="{FF2B5EF4-FFF2-40B4-BE49-F238E27FC236}">
                <a16:creationId xmlns:a16="http://schemas.microsoft.com/office/drawing/2014/main" id="{2EE044E4-5F1B-E227-3F64-A0D7A8F19C37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9304100" y="24879001"/>
            <a:ext cx="24323935" cy="7694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4400" b="1" dirty="0"/>
              <a:t>Hypo-methylated genes in T1 P14 vs other patients</a:t>
            </a:r>
            <a:endParaRPr lang="it-IT" sz="4400" b="1" dirty="0"/>
          </a:p>
        </p:txBody>
      </p: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EBCB20CA-9260-6087-BAD7-01B7E1BAF72D}"/>
              </a:ext>
            </a:extLst>
          </p:cNvPr>
          <p:cNvGrpSpPr/>
          <p:nvPr/>
        </p:nvGrpSpPr>
        <p:grpSpPr>
          <a:xfrm>
            <a:off x="9304101" y="25641556"/>
            <a:ext cx="10622169" cy="8238445"/>
            <a:chOff x="792163" y="15684500"/>
            <a:chExt cx="14268450" cy="11066463"/>
          </a:xfrm>
        </p:grpSpPr>
        <p:sp>
          <p:nvSpPr>
            <p:cNvPr id="23" name="CasellaDiTesto 6">
              <a:extLst>
                <a:ext uri="{FF2B5EF4-FFF2-40B4-BE49-F238E27FC236}">
                  <a16:creationId xmlns:a16="http://schemas.microsoft.com/office/drawing/2014/main" id="{0DFC2131-8ED9-0E5A-4864-DB8965E8A6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24836" y="15684500"/>
              <a:ext cx="8208912" cy="769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Gene </a:t>
              </a:r>
              <a:r>
                <a:rPr lang="it-IT" sz="4400" b="1" dirty="0" err="1"/>
                <a:t>ontology</a:t>
              </a:r>
              <a:endParaRPr lang="it-IT" sz="4400" b="1" dirty="0"/>
            </a:p>
          </p:txBody>
        </p:sp>
        <p:pic>
          <p:nvPicPr>
            <p:cNvPr id="24" name="Picture 4" descr="C:\Users\utente\Desktop\CD34 methylation analysis\09June2022\PZ14 T1\CD34_TSSPM_09June2022_Enrich_PZ14_t1_Hypo_c5.png">
              <a:extLst>
                <a:ext uri="{FF2B5EF4-FFF2-40B4-BE49-F238E27FC236}">
                  <a16:creationId xmlns:a16="http://schemas.microsoft.com/office/drawing/2014/main" id="{0E71BDA9-784F-621E-DC48-EC4C371CC83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/>
            <a:srcRect t="6519" r="1788"/>
            <a:stretch>
              <a:fillRect/>
            </a:stretch>
          </p:blipFill>
          <p:spPr bwMode="auto">
            <a:xfrm>
              <a:off x="792163" y="16567150"/>
              <a:ext cx="14268450" cy="10183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993DA3B0-A157-6EC1-607B-646F84C6EDE5}"/>
              </a:ext>
            </a:extLst>
          </p:cNvPr>
          <p:cNvGrpSpPr/>
          <p:nvPr/>
        </p:nvGrpSpPr>
        <p:grpSpPr>
          <a:xfrm>
            <a:off x="21431240" y="25632332"/>
            <a:ext cx="10546534" cy="8154352"/>
            <a:chOff x="15500350" y="15900648"/>
            <a:chExt cx="14166850" cy="10953502"/>
          </a:xfrm>
        </p:grpSpPr>
        <p:sp>
          <p:nvSpPr>
            <p:cNvPr id="26" name="CasellaDiTesto 7">
              <a:extLst>
                <a:ext uri="{FF2B5EF4-FFF2-40B4-BE49-F238E27FC236}">
                  <a16:creationId xmlns:a16="http://schemas.microsoft.com/office/drawing/2014/main" id="{698E6137-B58E-4985-BB11-523FCC90E6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118039" y="15900648"/>
              <a:ext cx="8677349" cy="7694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Pathway </a:t>
              </a:r>
              <a:r>
                <a:rPr lang="it-IT" sz="4400" b="1" dirty="0" err="1"/>
                <a:t>analysis</a:t>
              </a:r>
              <a:endParaRPr lang="it-IT" sz="4400" b="1" dirty="0"/>
            </a:p>
          </p:txBody>
        </p:sp>
        <p:pic>
          <p:nvPicPr>
            <p:cNvPr id="27" name="Picture 5" descr="C:\Users\utente\Desktop\CD34 methylation analysis\09June2022\PZ14 T1\CD34_TSSPM_09June2022_Enrich_PZ14_t1_Hypo_c2.png">
              <a:extLst>
                <a:ext uri="{FF2B5EF4-FFF2-40B4-BE49-F238E27FC236}">
                  <a16:creationId xmlns:a16="http://schemas.microsoft.com/office/drawing/2014/main" id="{410FA05E-5955-04F0-8C12-F21D3A855A6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/>
            <a:srcRect t="6519" r="1788"/>
            <a:stretch>
              <a:fillRect/>
            </a:stretch>
          </p:blipFill>
          <p:spPr bwMode="auto">
            <a:xfrm>
              <a:off x="15500350" y="16741775"/>
              <a:ext cx="14166850" cy="10112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60CA3F26-ED33-8A3A-B2BA-2B3C47E29D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37856" y="24632444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004305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3C537C6-BEC3-CF52-7837-A90802D9EB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00013"/>
            <a:ext cx="13898563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6000" b="1" dirty="0"/>
              <a:t>Supplementary  F</a:t>
            </a:r>
            <a:r>
              <a:rPr lang="it-IT" sz="6000" b="1" dirty="0" err="1"/>
              <a:t>igure</a:t>
            </a:r>
            <a:r>
              <a:rPr lang="it-IT" sz="6000" b="1" dirty="0"/>
              <a:t> S5</a:t>
            </a:r>
          </a:p>
        </p:txBody>
      </p:sp>
      <p:sp>
        <p:nvSpPr>
          <p:cNvPr id="5" name="Rettangolo 7">
            <a:extLst>
              <a:ext uri="{FF2B5EF4-FFF2-40B4-BE49-F238E27FC236}">
                <a16:creationId xmlns:a16="http://schemas.microsoft.com/office/drawing/2014/main" id="{D38779C3-8351-8D79-6A8E-3F9007B1E32E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2880620" y="2610622"/>
            <a:ext cx="32529672" cy="76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it-IT" sz="4400" b="1" dirty="0"/>
              <a:t>Hyper-methylated genes in P3 T4 vs all other T4</a:t>
            </a:r>
            <a:endParaRPr lang="it-IT" altLang="it-IT" sz="4400" b="1" dirty="0"/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725A3091-E35B-EE46-13AD-956843D3BFA7}"/>
              </a:ext>
            </a:extLst>
          </p:cNvPr>
          <p:cNvGrpSpPr/>
          <p:nvPr/>
        </p:nvGrpSpPr>
        <p:grpSpPr>
          <a:xfrm>
            <a:off x="3401616" y="3433143"/>
            <a:ext cx="14744700" cy="11447464"/>
            <a:chOff x="1097360" y="3062385"/>
            <a:chExt cx="14744700" cy="11447464"/>
          </a:xfrm>
        </p:grpSpPr>
        <p:sp>
          <p:nvSpPr>
            <p:cNvPr id="6" name="CasellaDiTesto 6">
              <a:extLst>
                <a:ext uri="{FF2B5EF4-FFF2-40B4-BE49-F238E27FC236}">
                  <a16:creationId xmlns:a16="http://schemas.microsoft.com/office/drawing/2014/main" id="{63EB7F2B-740D-D982-E860-A8D709CFD7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8893" y="3062385"/>
              <a:ext cx="8280920" cy="769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it-IT" altLang="it-IT" sz="4400" b="1" dirty="0"/>
                <a:t>Gene </a:t>
              </a:r>
              <a:r>
                <a:rPr lang="it-IT" altLang="it-IT" sz="4400" b="1" dirty="0" err="1"/>
                <a:t>ontology</a:t>
              </a:r>
              <a:endParaRPr lang="it-IT" altLang="it-IT" sz="4400" b="1" dirty="0"/>
            </a:p>
          </p:txBody>
        </p:sp>
        <p:pic>
          <p:nvPicPr>
            <p:cNvPr id="7" name="Picture 17" descr="C:\Users\utente\Desktop\CD34 methylation analysis\09June2022\PZ3 T4\CD34_TSSPM_09June2022_Enrich_PZ3_t4_Hyper_c5.png">
              <a:extLst>
                <a:ext uri="{FF2B5EF4-FFF2-40B4-BE49-F238E27FC236}">
                  <a16:creationId xmlns:a16="http://schemas.microsoft.com/office/drawing/2014/main" id="{E028DC76-1BE1-071B-B2C1-E31EDBF6B2D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" t="5452" r="1788" b="400"/>
            <a:stretch>
              <a:fillRect/>
            </a:stretch>
          </p:blipFill>
          <p:spPr bwMode="auto">
            <a:xfrm>
              <a:off x="1097360" y="3854549"/>
              <a:ext cx="14744700" cy="10655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B47FD0F9-6575-9B5B-6438-3CC5CB19D5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6486" y="1892775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898D8907-D4AE-0378-2DB3-8C6EB53170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1391" y="16877803"/>
            <a:ext cx="1800225" cy="101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3908425" eaLnBrk="0" fontAlgn="base" hangingPunct="0">
              <a:spcBef>
                <a:spcPct val="0"/>
              </a:spcBef>
              <a:spcAft>
                <a:spcPct val="0"/>
              </a:spcAft>
              <a:defRPr sz="7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6000" b="1" dirty="0"/>
              <a:t>b</a:t>
            </a:r>
          </a:p>
        </p:txBody>
      </p:sp>
      <p:grpSp>
        <p:nvGrpSpPr>
          <p:cNvPr id="12" name="Gruppo 11">
            <a:extLst>
              <a:ext uri="{FF2B5EF4-FFF2-40B4-BE49-F238E27FC236}">
                <a16:creationId xmlns:a16="http://schemas.microsoft.com/office/drawing/2014/main" id="{6BEB2965-3CB0-3A50-F5AB-84DA94CF668D}"/>
              </a:ext>
            </a:extLst>
          </p:cNvPr>
          <p:cNvGrpSpPr/>
          <p:nvPr/>
        </p:nvGrpSpPr>
        <p:grpSpPr>
          <a:xfrm>
            <a:off x="20252842" y="3453485"/>
            <a:ext cx="15157450" cy="11405989"/>
            <a:chOff x="17948586" y="3082727"/>
            <a:chExt cx="15157450" cy="11405989"/>
          </a:xfrm>
        </p:grpSpPr>
        <p:sp>
          <p:nvSpPr>
            <p:cNvPr id="10" name="CasellaDiTesto 10">
              <a:extLst>
                <a:ext uri="{FF2B5EF4-FFF2-40B4-BE49-F238E27FC236}">
                  <a16:creationId xmlns:a16="http://schemas.microsoft.com/office/drawing/2014/main" id="{C189A7F9-842B-EDF2-700B-137CCE6CDC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962740" y="3082727"/>
              <a:ext cx="9001000" cy="769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defTabSz="3908425" eaLnBrk="0" fontAlgn="base" hangingPunct="0">
                <a:spcBef>
                  <a:spcPct val="0"/>
                </a:spcBef>
                <a:spcAft>
                  <a:spcPct val="0"/>
                </a:spcAft>
                <a:defRPr sz="7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it-IT" altLang="it-IT" sz="4400" b="1" dirty="0" err="1"/>
                <a:t>Immunological</a:t>
              </a:r>
              <a:r>
                <a:rPr lang="it-IT" altLang="it-IT" sz="4400" b="1" dirty="0"/>
                <a:t> signature</a:t>
              </a:r>
            </a:p>
          </p:txBody>
        </p:sp>
        <p:pic>
          <p:nvPicPr>
            <p:cNvPr id="11" name="Picture 19" descr="C:\Users\utente\Desktop\CD34 methylation analysis\09June2022\PZ3 T4\CD34_TSSPM_09June2022_Enrich_PZ3_t4_Hyper_c7.png">
              <a:extLst>
                <a:ext uri="{FF2B5EF4-FFF2-40B4-BE49-F238E27FC236}">
                  <a16:creationId xmlns:a16="http://schemas.microsoft.com/office/drawing/2014/main" id="{DB5D1168-B1F4-FA65-2274-506E05109AF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52"/>
            <a:stretch>
              <a:fillRect/>
            </a:stretch>
          </p:blipFill>
          <p:spPr bwMode="auto">
            <a:xfrm>
              <a:off x="17948586" y="3831828"/>
              <a:ext cx="15157450" cy="10656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0FA7BC0F-58D2-E90F-A81D-E42F523749A7}"/>
              </a:ext>
            </a:extLst>
          </p:cNvPr>
          <p:cNvGrpSpPr/>
          <p:nvPr/>
        </p:nvGrpSpPr>
        <p:grpSpPr>
          <a:xfrm>
            <a:off x="1444184" y="19007197"/>
            <a:ext cx="15921037" cy="11931651"/>
            <a:chOff x="436563" y="3875087"/>
            <a:chExt cx="15921037" cy="11931651"/>
          </a:xfrm>
        </p:grpSpPr>
        <p:pic>
          <p:nvPicPr>
            <p:cNvPr id="14" name="Picture 2" descr="C:\Users\utente\Desktop\CD34 methylation analysis\09June2022\PZ3 T1\CD34_TSSPM_09June2022_Enrich_PZ3_t1_Hypo_c2.png">
              <a:extLst>
                <a:ext uri="{FF2B5EF4-FFF2-40B4-BE49-F238E27FC236}">
                  <a16:creationId xmlns:a16="http://schemas.microsoft.com/office/drawing/2014/main" id="{F4DF72FD-71CA-524F-5A65-6B0F69CE44F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/>
            <a:srcRect t="6519"/>
            <a:stretch>
              <a:fillRect/>
            </a:stretch>
          </p:blipFill>
          <p:spPr bwMode="auto">
            <a:xfrm>
              <a:off x="436563" y="4645025"/>
              <a:ext cx="15921037" cy="111617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CasellaDiTesto 7">
              <a:extLst>
                <a:ext uri="{FF2B5EF4-FFF2-40B4-BE49-F238E27FC236}">
                  <a16:creationId xmlns:a16="http://schemas.microsoft.com/office/drawing/2014/main" id="{05323690-BECD-0566-1292-4E508CB8D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2828" y="3875087"/>
              <a:ext cx="9220520" cy="7683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/>
                <a:t>Pathway </a:t>
              </a:r>
              <a:r>
                <a:rPr lang="it-IT" sz="4400" b="1" dirty="0" err="1"/>
                <a:t>analysis</a:t>
              </a:r>
              <a:endParaRPr lang="it-IT" sz="4400" b="1" dirty="0"/>
            </a:p>
          </p:txBody>
        </p:sp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76600D38-CB8E-D679-BB5D-9D3113024A54}"/>
              </a:ext>
            </a:extLst>
          </p:cNvPr>
          <p:cNvGrpSpPr/>
          <p:nvPr/>
        </p:nvGrpSpPr>
        <p:grpSpPr>
          <a:xfrm>
            <a:off x="17933546" y="18934172"/>
            <a:ext cx="16197263" cy="12158663"/>
            <a:chOff x="16925925" y="3802062"/>
            <a:chExt cx="16197263" cy="12158663"/>
          </a:xfrm>
        </p:grpSpPr>
        <p:pic>
          <p:nvPicPr>
            <p:cNvPr id="17" name="Picture 3" descr="C:\Users\utente\Desktop\CD34 methylation analysis\09June2022\PZ3 T1\CD34_TSSPM_09June2022_Enrich_PZ3_t1_Hypo_c7.png">
              <a:extLst>
                <a:ext uri="{FF2B5EF4-FFF2-40B4-BE49-F238E27FC236}">
                  <a16:creationId xmlns:a16="http://schemas.microsoft.com/office/drawing/2014/main" id="{A58827C0-D9D1-F60A-9883-0AC89F96827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/>
            <a:srcRect t="6252"/>
            <a:stretch>
              <a:fillRect/>
            </a:stretch>
          </p:blipFill>
          <p:spPr bwMode="auto">
            <a:xfrm>
              <a:off x="16925925" y="4572000"/>
              <a:ext cx="16197263" cy="11388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CasellaDiTesto 10">
              <a:extLst>
                <a:ext uri="{FF2B5EF4-FFF2-40B4-BE49-F238E27FC236}">
                  <a16:creationId xmlns:a16="http://schemas.microsoft.com/office/drawing/2014/main" id="{7D6E0F6B-CAA2-0776-18D3-25B66ED8F3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950092" y="3802062"/>
              <a:ext cx="9653608" cy="7683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4400" b="1" dirty="0" err="1"/>
                <a:t>Immunological</a:t>
              </a:r>
              <a:r>
                <a:rPr lang="it-IT" sz="4400" b="1" dirty="0"/>
                <a:t> signature</a:t>
              </a:r>
            </a:p>
          </p:txBody>
        </p:sp>
      </p:grpSp>
      <p:sp>
        <p:nvSpPr>
          <p:cNvPr id="19" name="Rettangolo 7">
            <a:extLst>
              <a:ext uri="{FF2B5EF4-FFF2-40B4-BE49-F238E27FC236}">
                <a16:creationId xmlns:a16="http://schemas.microsoft.com/office/drawing/2014/main" id="{F51167F9-8013-971F-4FD1-C59C78DA8A81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1007621" y="17592735"/>
            <a:ext cx="33412113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4400" b="1" dirty="0"/>
              <a:t>Hypo-methylated genes in T1 P3 vs other patients</a:t>
            </a:r>
            <a:endParaRPr lang="it-IT" sz="4400" b="1" dirty="0"/>
          </a:p>
        </p:txBody>
      </p:sp>
    </p:spTree>
    <p:extLst>
      <p:ext uri="{BB962C8B-B14F-4D97-AF65-F5344CB8AC3E}">
        <p14:creationId xmlns:p14="http://schemas.microsoft.com/office/powerpoint/2010/main" val="19307200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0</TotalTime>
  <Words>136</Words>
  <Application>Microsoft Office PowerPoint</Application>
  <PresentationFormat>Personalizzato</PresentationFormat>
  <Paragraphs>44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8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tefania</dc:creator>
  <cp:lastModifiedBy>Ilaria Laurenzana</cp:lastModifiedBy>
  <cp:revision>238</cp:revision>
  <dcterms:created xsi:type="dcterms:W3CDTF">2021-08-23T07:56:52Z</dcterms:created>
  <dcterms:modified xsi:type="dcterms:W3CDTF">2023-02-27T09:35:01Z</dcterms:modified>
</cp:coreProperties>
</file>